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07" r:id="rId2"/>
    <p:sldId id="288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3826" autoAdjust="0"/>
  </p:normalViewPr>
  <p:slideViewPr>
    <p:cSldViewPr snapToGrid="0">
      <p:cViewPr>
        <p:scale>
          <a:sx n="66" d="100"/>
          <a:sy n="66" d="100"/>
        </p:scale>
        <p:origin x="668" y="-2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1669B5-4C99-40E8-ABD1-1FAFEA5FC457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F7B1CA-106B-447B-B483-723241D1D4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08109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Case 1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1B0E9E-BA41-44A0-841D-0C5A9A4B563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84289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Case 2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F7B1CA-106B-447B-B483-723241D1D4BE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46910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6E3025-1844-F274-D977-7AE76CB133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490820E-1DB0-521B-6963-6BFA4A9E4A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B4AD9F-0037-F10D-2774-5DD294C76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ADB3728-DFF2-DB4B-DC47-88BB760D1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8B814E1-BC16-EABE-FB09-2DE12A76F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3936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EAD3D4-5941-2FDA-4D4D-6D714A26C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9F1BAB5-EA02-5DE0-84AA-33FBFE3166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F35A97-542A-F421-766D-AA7989B78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B07D68-05FC-D552-6090-1A58327CA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6654BE-1122-1C56-C8AA-8D70B7180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7379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284FB84-10FA-4F4F-7768-D159CF8EAC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03CD418-A3C0-CD6A-5860-43B30FF8B5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4F17BC-28BF-5D9D-A7C3-638F113BA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14C5AB-E8FA-747D-8086-6DE281D3D1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6102A9-6623-1F06-256D-F1A2A2746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3013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2DEC08-42EA-DDED-A010-19A25E3A1C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62A2A9-78FF-A2FC-8D5C-479821C747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F02A96-F567-4871-2612-398B2411B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F91D6F-A24C-3AE1-77D4-084112C70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AE1942D-D6C6-8D50-4343-4BD41FF14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8783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C5E254-B2D1-1388-C91C-0AB4798A24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56BEFF-DE80-132F-B62D-1F1FD8CBA1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EF5776-EFBE-9DE7-38CB-5D53F6F5C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E6FCEC-FD6E-5240-6A2F-BB68C5CF1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3EA3058-3C20-3ED2-D529-B6DE6EEB0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185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A4E732-B141-3996-A965-B831C8C667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2BCB09-5343-7DBB-D24F-C46B8446A3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716F740-4611-28AE-D982-4A2B089B76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966E1DD-8A57-7D5E-09A6-F49058544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7390C08-9193-92A2-B647-EFF2A3C7F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2DD8530-B217-E8F8-B8AD-C332D30C9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344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C5ECD9-76F0-5284-B8E5-16E5CE070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C799403-D815-5D5A-15BF-C3FB3C4595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C6E8E63-E0EA-C3EF-DE14-1D4EB1673F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E9CE393-BC47-6A93-C3D7-532198E954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1003A93-86D3-C0FE-6BD9-707790FBFD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9C1740C-6B47-4CAA-9128-2673702FB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B296AE5-0F2C-04C6-EE88-DC509064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CCABE12-7BD2-8B98-776D-D4C56415D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640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1B6676-BCC7-A011-B97D-C73369102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00D298F-B97D-340D-0D3C-BD93A23E4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1F8A57B-3FE5-C91A-48F2-5BDBA5E54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C538C46-B6B7-2E64-8388-CBA9395F0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97761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634E387-FE7C-E3B6-F730-9DE238CE5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DF75C59-AE8F-6D76-D008-746ABD0B0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345BA0F-888B-189A-88BE-9503FD4FE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2231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5BDFD5-3FCB-851E-612D-601EB17F21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AB59E2-5C4F-88CA-2CC5-4BB52D6D82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92FC16-8A5C-BD68-6C87-F0FD7F35A2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181F482-52CF-5F95-98B9-DEC60BDEB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44034E-6A21-2894-1D4F-AB6F3966C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EAB6A8E-A9DD-D8A3-94EA-DE97C7919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2658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B420AC-6292-D8B4-5B58-E6EE3607EE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BA42C85-9605-12F5-ED7A-AC8D365319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9977371-CE77-1939-E3E4-A984A47F04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E9D6FE5-D421-50E2-11AE-3E997782FA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1FA0C57-4EE4-3C9F-522A-153CE8CFF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3B7462B-2621-B06E-7C2B-7BE78C2AB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3179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CF8AF54-B07D-84A8-4687-D3CA8B5516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F6B12B0-328C-0F40-7D5B-0795C192D2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E12642-5A72-9DF9-6C6B-1C50E5151C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A4E38-DFA5-4C5D-B925-75561649E6FA}" type="datetimeFigureOut">
              <a:rPr lang="zh-CN" altLang="en-US" smtClean="0"/>
              <a:t>2022/9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D7C070-90D7-AA70-6705-91E72B7877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B159E9-9473-D85A-CED0-8F6D596B71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7B901-F4D5-4E6C-8B51-3413448AE9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1938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4">
            <a:extLst>
              <a:ext uri="{FF2B5EF4-FFF2-40B4-BE49-F238E27FC236}">
                <a16:creationId xmlns:a16="http://schemas.microsoft.com/office/drawing/2014/main" id="{9812326D-B886-44BD-956B-892F3C252A0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608" t="12641" r="1626" b="50000"/>
          <a:stretch/>
        </p:blipFill>
        <p:spPr>
          <a:xfrm>
            <a:off x="1597659" y="573372"/>
            <a:ext cx="2865119" cy="2321110"/>
          </a:xfrm>
          <a:prstGeom prst="rect">
            <a:avLst/>
          </a:prstGeom>
        </p:spPr>
      </p:pic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1E7070D9-3BAE-4507-BB9C-CF3821C2D12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55" t="53244" r="33579" b="9397"/>
          <a:stretch/>
        </p:blipFill>
        <p:spPr>
          <a:xfrm>
            <a:off x="1597659" y="3047064"/>
            <a:ext cx="2865119" cy="2321110"/>
          </a:xfrm>
          <a:prstGeom prst="rect">
            <a:avLst/>
          </a:prstGeom>
        </p:spPr>
      </p:pic>
      <p:pic>
        <p:nvPicPr>
          <p:cNvPr id="6" name="内容占位符 4">
            <a:extLst>
              <a:ext uri="{FF2B5EF4-FFF2-40B4-BE49-F238E27FC236}">
                <a16:creationId xmlns:a16="http://schemas.microsoft.com/office/drawing/2014/main" id="{F0591759-CA34-4DE2-9D72-CF762567794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36" t="28920" r="21907" b="53736"/>
          <a:stretch/>
        </p:blipFill>
        <p:spPr>
          <a:xfrm>
            <a:off x="4765576" y="3047064"/>
            <a:ext cx="2865119" cy="2321110"/>
          </a:xfrm>
          <a:prstGeom prst="rect">
            <a:avLst/>
          </a:prstGeom>
        </p:spPr>
      </p:pic>
      <p:pic>
        <p:nvPicPr>
          <p:cNvPr id="7" name="内容占位符 4">
            <a:extLst>
              <a:ext uri="{FF2B5EF4-FFF2-40B4-BE49-F238E27FC236}">
                <a16:creationId xmlns:a16="http://schemas.microsoft.com/office/drawing/2014/main" id="{EF8AF8C8-E0F8-4A21-A69D-A7A4CFE6CE2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71" t="29805" r="41971" b="52851"/>
          <a:stretch/>
        </p:blipFill>
        <p:spPr>
          <a:xfrm>
            <a:off x="4765575" y="573372"/>
            <a:ext cx="2865119" cy="2321110"/>
          </a:xfrm>
          <a:prstGeom prst="rect">
            <a:avLst/>
          </a:prstGeom>
        </p:spPr>
      </p:pic>
      <p:pic>
        <p:nvPicPr>
          <p:cNvPr id="8" name="内容占位符 4">
            <a:extLst>
              <a:ext uri="{FF2B5EF4-FFF2-40B4-BE49-F238E27FC236}">
                <a16:creationId xmlns:a16="http://schemas.microsoft.com/office/drawing/2014/main" id="{33F31F60-91A0-459A-AF1D-354611C82AC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903" t="12137" r="34581" b="49726"/>
          <a:stretch/>
        </p:blipFill>
        <p:spPr>
          <a:xfrm>
            <a:off x="7933491" y="573372"/>
            <a:ext cx="2874959" cy="2321110"/>
          </a:xfrm>
          <a:prstGeom prst="rect">
            <a:avLst/>
          </a:prstGeom>
        </p:spPr>
      </p:pic>
      <p:pic>
        <p:nvPicPr>
          <p:cNvPr id="9" name="内容占位符 4">
            <a:extLst>
              <a:ext uri="{FF2B5EF4-FFF2-40B4-BE49-F238E27FC236}">
                <a16:creationId xmlns:a16="http://schemas.microsoft.com/office/drawing/2014/main" id="{98FB0E04-A929-4C46-B567-52CBD2D9F13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5" t="53496" r="67479" b="8367"/>
          <a:stretch/>
        </p:blipFill>
        <p:spPr>
          <a:xfrm>
            <a:off x="7933490" y="3047064"/>
            <a:ext cx="2874960" cy="232111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AF215173-329D-4D7F-8E75-EF40B2CFA0F3}"/>
              </a:ext>
            </a:extLst>
          </p:cNvPr>
          <p:cNvSpPr txBox="1"/>
          <p:nvPr/>
        </p:nvSpPr>
        <p:spPr>
          <a:xfrm>
            <a:off x="1557018" y="5368174"/>
            <a:ext cx="294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-baseline scan 6/5/20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C43A121-C43F-4EB6-9056-BF127DCD0C80}"/>
              </a:ext>
            </a:extLst>
          </p:cNvPr>
          <p:cNvSpPr txBox="1"/>
          <p:nvPr/>
        </p:nvSpPr>
        <p:spPr>
          <a:xfrm>
            <a:off x="7933489" y="5368174"/>
            <a:ext cx="2865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scan 22/12/2020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5719B29-17B2-428F-9125-76383A0591C5}"/>
              </a:ext>
            </a:extLst>
          </p:cNvPr>
          <p:cNvSpPr txBox="1"/>
          <p:nvPr/>
        </p:nvSpPr>
        <p:spPr>
          <a:xfrm>
            <a:off x="4724934" y="5368174"/>
            <a:ext cx="294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 scan 26/10/2020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1FF8F9A4-B8AB-490E-B203-569DC09FC4CB}"/>
              </a:ext>
            </a:extLst>
          </p:cNvPr>
          <p:cNvCxnSpPr>
            <a:cxnSpLocks/>
            <a:stCxn id="10" idx="2"/>
          </p:cNvCxnSpPr>
          <p:nvPr/>
        </p:nvCxnSpPr>
        <p:spPr>
          <a:xfrm>
            <a:off x="3030218" y="5737506"/>
            <a:ext cx="251126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1AD26589-F543-495C-9CA5-7989C7F7A410}"/>
              </a:ext>
            </a:extLst>
          </p:cNvPr>
          <p:cNvCxnSpPr>
            <a:cxnSpLocks/>
          </p:cNvCxnSpPr>
          <p:nvPr/>
        </p:nvCxnSpPr>
        <p:spPr>
          <a:xfrm>
            <a:off x="6554804" y="5737506"/>
            <a:ext cx="361909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4FD4E44D-7845-4E28-B58D-98444C13BC01}"/>
              </a:ext>
            </a:extLst>
          </p:cNvPr>
          <p:cNvSpPr txBox="1"/>
          <p:nvPr/>
        </p:nvSpPr>
        <p:spPr>
          <a:xfrm>
            <a:off x="6391040" y="5727212"/>
            <a:ext cx="3681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 mAb starting from 29/10/2020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内容占位符 4">
            <a:extLst>
              <a:ext uri="{FF2B5EF4-FFF2-40B4-BE49-F238E27FC236}">
                <a16:creationId xmlns:a16="http://schemas.microsoft.com/office/drawing/2014/main" id="{78BB1BEB-C03D-4C0E-C23D-C571686D3D8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74" t="14993" r="36525" b="83198"/>
          <a:stretch/>
        </p:blipFill>
        <p:spPr>
          <a:xfrm>
            <a:off x="10760291" y="750357"/>
            <a:ext cx="45719" cy="110068"/>
          </a:xfrm>
          <a:prstGeom prst="rect">
            <a:avLst/>
          </a:prstGeom>
        </p:spPr>
      </p:pic>
      <p:pic>
        <p:nvPicPr>
          <p:cNvPr id="13" name="内容占位符 4">
            <a:extLst>
              <a:ext uri="{FF2B5EF4-FFF2-40B4-BE49-F238E27FC236}">
                <a16:creationId xmlns:a16="http://schemas.microsoft.com/office/drawing/2014/main" id="{D85D883C-CA1D-FCFD-97ED-6B49A5CFE20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74" t="14993" r="36525" b="83198"/>
          <a:stretch/>
        </p:blipFill>
        <p:spPr>
          <a:xfrm>
            <a:off x="10762731" y="3213999"/>
            <a:ext cx="45719" cy="110068"/>
          </a:xfrm>
          <a:prstGeom prst="rect">
            <a:avLst/>
          </a:prstGeom>
        </p:spPr>
      </p:pic>
      <p:pic>
        <p:nvPicPr>
          <p:cNvPr id="15" name="内容占位符 4">
            <a:extLst>
              <a:ext uri="{FF2B5EF4-FFF2-40B4-BE49-F238E27FC236}">
                <a16:creationId xmlns:a16="http://schemas.microsoft.com/office/drawing/2014/main" id="{5E60675B-0F81-E86B-35BF-63187B6460A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417" t="14941" r="37082" b="83250"/>
          <a:stretch/>
        </p:blipFill>
        <p:spPr>
          <a:xfrm>
            <a:off x="10633505" y="744006"/>
            <a:ext cx="45719" cy="110068"/>
          </a:xfrm>
          <a:prstGeom prst="rect">
            <a:avLst/>
          </a:prstGeom>
        </p:spPr>
      </p:pic>
      <p:pic>
        <p:nvPicPr>
          <p:cNvPr id="16" name="内容占位符 4">
            <a:extLst>
              <a:ext uri="{FF2B5EF4-FFF2-40B4-BE49-F238E27FC236}">
                <a16:creationId xmlns:a16="http://schemas.microsoft.com/office/drawing/2014/main" id="{279F8D4D-0A0C-ABF4-9F58-03D93B9B84E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417" t="14941" r="37082" b="83250"/>
          <a:stretch/>
        </p:blipFill>
        <p:spPr>
          <a:xfrm>
            <a:off x="10641445" y="3208709"/>
            <a:ext cx="45719" cy="1100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5296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4">
            <a:extLst>
              <a:ext uri="{FF2B5EF4-FFF2-40B4-BE49-F238E27FC236}">
                <a16:creationId xmlns:a16="http://schemas.microsoft.com/office/drawing/2014/main" id="{BDAADAA6-9ABE-4BB5-97A9-22645328DCE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71" t="15833" r="31825" b="47781"/>
          <a:stretch/>
        </p:blipFill>
        <p:spPr>
          <a:xfrm>
            <a:off x="2568786" y="1921933"/>
            <a:ext cx="3498270" cy="2565400"/>
          </a:xfrm>
          <a:prstGeom prst="rect">
            <a:avLst/>
          </a:prstGeom>
        </p:spPr>
      </p:pic>
      <p:pic>
        <p:nvPicPr>
          <p:cNvPr id="6" name="内容占位符 4">
            <a:extLst>
              <a:ext uri="{FF2B5EF4-FFF2-40B4-BE49-F238E27FC236}">
                <a16:creationId xmlns:a16="http://schemas.microsoft.com/office/drawing/2014/main" id="{AA4BE20C-1153-488A-AA21-A71E6CEFEC3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434" t="56500" r="1708" b="11005"/>
          <a:stretch/>
        </p:blipFill>
        <p:spPr>
          <a:xfrm>
            <a:off x="6270119" y="1921934"/>
            <a:ext cx="3533181" cy="256539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7447BD74-899C-4381-92B6-A29702F886F1}"/>
              </a:ext>
            </a:extLst>
          </p:cNvPr>
          <p:cNvSpPr txBox="1"/>
          <p:nvPr/>
        </p:nvSpPr>
        <p:spPr>
          <a:xfrm>
            <a:off x="2844721" y="4556667"/>
            <a:ext cx="294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 scan 22/2/202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A33CFD0-F5E7-45A5-A887-454ECD7F4A29}"/>
              </a:ext>
            </a:extLst>
          </p:cNvPr>
          <p:cNvSpPr txBox="1"/>
          <p:nvPr/>
        </p:nvSpPr>
        <p:spPr>
          <a:xfrm>
            <a:off x="6563509" y="4556667"/>
            <a:ext cx="294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scan 13/4/2021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6742D871-DB68-4FD9-A4FE-5E85E1CFB21D}"/>
              </a:ext>
            </a:extLst>
          </p:cNvPr>
          <p:cNvCxnSpPr>
            <a:cxnSpLocks/>
          </p:cNvCxnSpPr>
          <p:nvPr/>
        </p:nvCxnSpPr>
        <p:spPr>
          <a:xfrm>
            <a:off x="4116188" y="4924398"/>
            <a:ext cx="4103252" cy="160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12">
            <a:extLst>
              <a:ext uri="{FF2B5EF4-FFF2-40B4-BE49-F238E27FC236}">
                <a16:creationId xmlns:a16="http://schemas.microsoft.com/office/drawing/2014/main" id="{D8EF0600-07E9-43C5-8D6F-5D2225BBB6D6}"/>
              </a:ext>
            </a:extLst>
          </p:cNvPr>
          <p:cNvSpPr txBox="1"/>
          <p:nvPr/>
        </p:nvSpPr>
        <p:spPr>
          <a:xfrm>
            <a:off x="4052453" y="4924398"/>
            <a:ext cx="3658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 mAb starting from 24/2/202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2279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nurse\Desktop\截图00.png"/>
          <p:cNvPicPr>
            <a:picLocks noChangeAspect="1" noChangeArrowheads="1"/>
          </p:cNvPicPr>
          <p:nvPr/>
        </p:nvPicPr>
        <p:blipFill rotWithShape="1">
          <a:blip r:embed="rId2"/>
          <a:srcRect l="3339" t="5443" r="3186"/>
          <a:stretch/>
        </p:blipFill>
        <p:spPr bwMode="auto">
          <a:xfrm>
            <a:off x="6023992" y="1844824"/>
            <a:ext cx="4032448" cy="2833150"/>
          </a:xfrm>
          <a:prstGeom prst="rect">
            <a:avLst/>
          </a:prstGeom>
          <a:noFill/>
        </p:spPr>
      </p:pic>
      <p:pic>
        <p:nvPicPr>
          <p:cNvPr id="1027" name="Picture 3" descr="C:\Users\nurse\Desktop\4630429.JPG"/>
          <p:cNvPicPr>
            <a:picLocks noChangeAspect="1" noChangeArrowheads="1"/>
          </p:cNvPicPr>
          <p:nvPr/>
        </p:nvPicPr>
        <p:blipFill rotWithShape="1">
          <a:blip r:embed="rId3"/>
          <a:srcRect t="11302" b="7688"/>
          <a:stretch/>
        </p:blipFill>
        <p:spPr bwMode="auto">
          <a:xfrm>
            <a:off x="2351584" y="1844824"/>
            <a:ext cx="3497264" cy="2833150"/>
          </a:xfrm>
          <a:prstGeom prst="rect">
            <a:avLst/>
          </a:prstGeom>
          <a:noFill/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0535F43-50A2-4655-BCF0-1D12D1D111EB}"/>
              </a:ext>
            </a:extLst>
          </p:cNvPr>
          <p:cNvSpPr txBox="1"/>
          <p:nvPr/>
        </p:nvSpPr>
        <p:spPr>
          <a:xfrm>
            <a:off x="2779416" y="4635535"/>
            <a:ext cx="264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 scan 8/1/202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14610302-0300-4321-BDE6-4CA3E4719DE8}"/>
              </a:ext>
            </a:extLst>
          </p:cNvPr>
          <p:cNvSpPr txBox="1"/>
          <p:nvPr/>
        </p:nvSpPr>
        <p:spPr>
          <a:xfrm>
            <a:off x="6719416" y="4631522"/>
            <a:ext cx="264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aluation scan 8/3/202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3166F1A1-C1C4-4368-9524-E10CC7DFED4B}"/>
              </a:ext>
            </a:extLst>
          </p:cNvPr>
          <p:cNvCxnSpPr>
            <a:cxnSpLocks/>
          </p:cNvCxnSpPr>
          <p:nvPr/>
        </p:nvCxnSpPr>
        <p:spPr>
          <a:xfrm flipV="1">
            <a:off x="4215700" y="4982458"/>
            <a:ext cx="3709035" cy="16748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C6668403-38F6-43F0-9E43-1C526292B07D}"/>
              </a:ext>
            </a:extLst>
          </p:cNvPr>
          <p:cNvSpPr txBox="1"/>
          <p:nvPr/>
        </p:nvSpPr>
        <p:spPr>
          <a:xfrm>
            <a:off x="4215698" y="4999206"/>
            <a:ext cx="3709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-1 mAb starting from 28/1/2022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2</Words>
  <Application>Microsoft Office PowerPoint</Application>
  <PresentationFormat>宽屏</PresentationFormat>
  <Paragraphs>14</Paragraphs>
  <Slides>3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 Kai</dc:creator>
  <cp:lastModifiedBy>Yan Kai</cp:lastModifiedBy>
  <cp:revision>6</cp:revision>
  <dcterms:created xsi:type="dcterms:W3CDTF">2022-09-18T09:00:05Z</dcterms:created>
  <dcterms:modified xsi:type="dcterms:W3CDTF">2022-09-18T09:21:31Z</dcterms:modified>
</cp:coreProperties>
</file>